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5" r:id="rId2"/>
  </p:sldIdLst>
  <p:sldSz cx="6858000" cy="9144000" type="screen4x3"/>
  <p:notesSz cx="6802438" cy="9934575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159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09900"/>
    <a:srgbClr val="7F7F7F"/>
    <a:srgbClr val="646464"/>
    <a:srgbClr val="8282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69" autoAdjust="0"/>
    <p:restoredTop sz="93194" autoAdjust="0"/>
  </p:normalViewPr>
  <p:slideViewPr>
    <p:cSldViewPr snapToGrid="0" snapToObjects="1">
      <p:cViewPr varScale="1">
        <p:scale>
          <a:sx n="81" d="100"/>
          <a:sy n="81" d="100"/>
        </p:scale>
        <p:origin x="784" y="76"/>
      </p:cViewPr>
      <p:guideLst>
        <p:guide orient="horz" pos="2880"/>
        <p:guide pos="2160"/>
        <p:guide orient="horz" pos="159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141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47343F-9011-4E48-ACD0-AFDBFF8B6C7E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4713" y="1241425"/>
            <a:ext cx="2513012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244" y="4781014"/>
            <a:ext cx="5441950" cy="39117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141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F467D0-B869-419D-8DA9-B631581B19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1866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6873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7524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4469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2364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5562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2652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606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3198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747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3419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3486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ltGray"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645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グループ化 45">
            <a:extLst>
              <a:ext uri="{FF2B5EF4-FFF2-40B4-BE49-F238E27FC236}">
                <a16:creationId xmlns:a16="http://schemas.microsoft.com/office/drawing/2014/main" id="{06B1E7C6-F537-4D63-B68D-3C5F1C5D3216}"/>
              </a:ext>
            </a:extLst>
          </p:cNvPr>
          <p:cNvGrpSpPr/>
          <p:nvPr/>
        </p:nvGrpSpPr>
        <p:grpSpPr>
          <a:xfrm>
            <a:off x="9139" y="373350"/>
            <a:ext cx="6807322" cy="4532373"/>
            <a:chOff x="9139" y="373350"/>
            <a:chExt cx="6807322" cy="4532373"/>
          </a:xfrm>
        </p:grpSpPr>
        <p:pic>
          <p:nvPicPr>
            <p:cNvPr id="50" name="図 49">
              <a:extLst>
                <a:ext uri="{FF2B5EF4-FFF2-40B4-BE49-F238E27FC236}">
                  <a16:creationId xmlns:a16="http://schemas.microsoft.com/office/drawing/2014/main" id="{EB575780-7FA0-4E17-A8F2-4559489F6DD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2588" y="2834476"/>
              <a:ext cx="1613074" cy="2071247"/>
            </a:xfrm>
            <a:prstGeom prst="rect">
              <a:avLst/>
            </a:prstGeom>
          </p:spPr>
        </p:pic>
        <p:pic>
          <p:nvPicPr>
            <p:cNvPr id="51" name="図 50">
              <a:extLst>
                <a:ext uri="{FF2B5EF4-FFF2-40B4-BE49-F238E27FC236}">
                  <a16:creationId xmlns:a16="http://schemas.microsoft.com/office/drawing/2014/main" id="{287CF157-D393-4D38-B315-DDC1DB971D2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48231" y="2834476"/>
              <a:ext cx="1609288" cy="2071247"/>
            </a:xfrm>
            <a:prstGeom prst="rect">
              <a:avLst/>
            </a:prstGeom>
          </p:spPr>
        </p:pic>
        <p:pic>
          <p:nvPicPr>
            <p:cNvPr id="52" name="図 51">
              <a:extLst>
                <a:ext uri="{FF2B5EF4-FFF2-40B4-BE49-F238E27FC236}">
                  <a16:creationId xmlns:a16="http://schemas.microsoft.com/office/drawing/2014/main" id="{E72D3514-AE3C-4016-A926-9D0529CD5A6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702151" y="2899681"/>
              <a:ext cx="1544815" cy="1983600"/>
            </a:xfrm>
            <a:prstGeom prst="rect">
              <a:avLst/>
            </a:prstGeom>
          </p:spPr>
        </p:pic>
        <p:pic>
          <p:nvPicPr>
            <p:cNvPr id="53" name="図 52">
              <a:extLst>
                <a:ext uri="{FF2B5EF4-FFF2-40B4-BE49-F238E27FC236}">
                  <a16:creationId xmlns:a16="http://schemas.microsoft.com/office/drawing/2014/main" id="{D551E058-9C2E-4E2F-BC09-0DAF626A933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263301" y="2899681"/>
              <a:ext cx="1541189" cy="1983600"/>
            </a:xfrm>
            <a:prstGeom prst="rect">
              <a:avLst/>
            </a:prstGeom>
          </p:spPr>
        </p:pic>
        <p:pic>
          <p:nvPicPr>
            <p:cNvPr id="54" name="図 53">
              <a:extLst>
                <a:ext uri="{FF2B5EF4-FFF2-40B4-BE49-F238E27FC236}">
                  <a16:creationId xmlns:a16="http://schemas.microsoft.com/office/drawing/2014/main" id="{7F922C7E-8325-432A-B7A8-9203F981D40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75675" y="584354"/>
              <a:ext cx="1586012" cy="1985030"/>
            </a:xfrm>
            <a:prstGeom prst="rect">
              <a:avLst/>
            </a:prstGeom>
          </p:spPr>
        </p:pic>
        <p:pic>
          <p:nvPicPr>
            <p:cNvPr id="55" name="図 54">
              <a:extLst>
                <a:ext uri="{FF2B5EF4-FFF2-40B4-BE49-F238E27FC236}">
                  <a16:creationId xmlns:a16="http://schemas.microsoft.com/office/drawing/2014/main" id="{053DF50A-DFBB-40D2-94B0-5FE1FCCCD76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699813" y="586031"/>
              <a:ext cx="1589365" cy="1981676"/>
            </a:xfrm>
            <a:prstGeom prst="rect">
              <a:avLst/>
            </a:prstGeom>
          </p:spPr>
        </p:pic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BE5D9EE7-C10A-4BA2-B09C-228A6DB116BE}"/>
                </a:ext>
              </a:extLst>
            </p:cNvPr>
            <p:cNvSpPr txBox="1"/>
            <p:nvPr/>
          </p:nvSpPr>
          <p:spPr>
            <a:xfrm>
              <a:off x="2310216" y="433115"/>
              <a:ext cx="6270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CpG2216</a:t>
              </a: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TLR9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86E5AD97-8378-4C2A-BB82-6A38E174CB2C}"/>
                </a:ext>
              </a:extLst>
            </p:cNvPr>
            <p:cNvSpPr txBox="1"/>
            <p:nvPr/>
          </p:nvSpPr>
          <p:spPr>
            <a:xfrm>
              <a:off x="796110" y="433115"/>
              <a:ext cx="6607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Loxoribine</a:t>
              </a:r>
              <a:endParaRPr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TLR7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91F6350A-54CC-424F-A2EA-AD23A6A031F2}"/>
                </a:ext>
              </a:extLst>
            </p:cNvPr>
            <p:cNvSpPr txBox="1"/>
            <p:nvPr/>
          </p:nvSpPr>
          <p:spPr>
            <a:xfrm>
              <a:off x="2103913" y="2184463"/>
              <a:ext cx="3291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HC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(24)</a:t>
              </a: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989857E4-0C15-41D8-B9D4-C977D4D6007F}"/>
                </a:ext>
              </a:extLst>
            </p:cNvPr>
            <p:cNvSpPr txBox="1"/>
            <p:nvPr/>
          </p:nvSpPr>
          <p:spPr>
            <a:xfrm>
              <a:off x="2339172" y="2184463"/>
              <a:ext cx="3595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iSLE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(26)</a:t>
              </a: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1B175B81-E080-4EE5-A4E2-22F099C8B6DF}"/>
                </a:ext>
              </a:extLst>
            </p:cNvPr>
            <p:cNvSpPr txBox="1"/>
            <p:nvPr/>
          </p:nvSpPr>
          <p:spPr>
            <a:xfrm>
              <a:off x="578324" y="2184463"/>
              <a:ext cx="3291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HC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(24)</a:t>
              </a: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F8962F5C-9437-4941-81F3-69CC6839AB12}"/>
                </a:ext>
              </a:extLst>
            </p:cNvPr>
            <p:cNvSpPr txBox="1"/>
            <p:nvPr/>
          </p:nvSpPr>
          <p:spPr>
            <a:xfrm>
              <a:off x="813583" y="2184463"/>
              <a:ext cx="3595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iSLE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(26)</a:t>
              </a: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12930A50-B5AA-4750-9E69-D7F794E2DDBF}"/>
                </a:ext>
              </a:extLst>
            </p:cNvPr>
            <p:cNvSpPr txBox="1"/>
            <p:nvPr/>
          </p:nvSpPr>
          <p:spPr>
            <a:xfrm>
              <a:off x="1165521" y="2438574"/>
              <a:ext cx="3751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aSLE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4A738BDA-AA4A-4351-B765-9B064CE13088}"/>
                </a:ext>
              </a:extLst>
            </p:cNvPr>
            <p:cNvSpPr txBox="1"/>
            <p:nvPr/>
          </p:nvSpPr>
          <p:spPr>
            <a:xfrm>
              <a:off x="1324684" y="2184463"/>
              <a:ext cx="3227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LN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(30)</a:t>
              </a:r>
            </a:p>
          </p:txBody>
        </p:sp>
        <p:cxnSp>
          <p:nvCxnSpPr>
            <p:cNvPr id="64" name="直線コネクタ 63">
              <a:extLst>
                <a:ext uri="{FF2B5EF4-FFF2-40B4-BE49-F238E27FC236}">
                  <a16:creationId xmlns:a16="http://schemas.microsoft.com/office/drawing/2014/main" id="{A569F16B-A00C-406F-8715-E7F5833C6C5F}"/>
                </a:ext>
              </a:extLst>
            </p:cNvPr>
            <p:cNvCxnSpPr/>
            <p:nvPr/>
          </p:nvCxnSpPr>
          <p:spPr>
            <a:xfrm>
              <a:off x="711767" y="948197"/>
              <a:ext cx="287002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id="{7425E327-8138-4E90-9D5A-5B11687348EC}"/>
                </a:ext>
              </a:extLst>
            </p:cNvPr>
            <p:cNvCxnSpPr/>
            <p:nvPr/>
          </p:nvCxnSpPr>
          <p:spPr>
            <a:xfrm>
              <a:off x="711767" y="869701"/>
              <a:ext cx="547191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線コネクタ 65">
              <a:extLst>
                <a:ext uri="{FF2B5EF4-FFF2-40B4-BE49-F238E27FC236}">
                  <a16:creationId xmlns:a16="http://schemas.microsoft.com/office/drawing/2014/main" id="{E233B9E0-8111-45A0-A801-5A73FAE6B602}"/>
                </a:ext>
              </a:extLst>
            </p:cNvPr>
            <p:cNvCxnSpPr/>
            <p:nvPr/>
          </p:nvCxnSpPr>
          <p:spPr>
            <a:xfrm>
              <a:off x="711767" y="794684"/>
              <a:ext cx="78470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F0F30939-B2BA-46FC-B1A0-71BFEB211AD4}"/>
                </a:ext>
              </a:extLst>
            </p:cNvPr>
            <p:cNvSpPr txBox="1"/>
            <p:nvPr/>
          </p:nvSpPr>
          <p:spPr>
            <a:xfrm>
              <a:off x="768706" y="921822"/>
              <a:ext cx="1771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0112AA66-505E-4F3E-8DC5-EE32D3C3953C}"/>
                </a:ext>
              </a:extLst>
            </p:cNvPr>
            <p:cNvSpPr txBox="1"/>
            <p:nvPr/>
          </p:nvSpPr>
          <p:spPr>
            <a:xfrm>
              <a:off x="986298" y="848383"/>
              <a:ext cx="27530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20F40B84-F6BC-4DDD-A50A-A85190B7DA14}"/>
                </a:ext>
              </a:extLst>
            </p:cNvPr>
            <p:cNvCxnSpPr/>
            <p:nvPr/>
          </p:nvCxnSpPr>
          <p:spPr>
            <a:xfrm>
              <a:off x="2243915" y="1083261"/>
              <a:ext cx="287002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線コネクタ 69">
              <a:extLst>
                <a:ext uri="{FF2B5EF4-FFF2-40B4-BE49-F238E27FC236}">
                  <a16:creationId xmlns:a16="http://schemas.microsoft.com/office/drawing/2014/main" id="{1C6F4B86-59E9-4A9B-8642-64E8632628DE}"/>
                </a:ext>
              </a:extLst>
            </p:cNvPr>
            <p:cNvCxnSpPr/>
            <p:nvPr/>
          </p:nvCxnSpPr>
          <p:spPr>
            <a:xfrm>
              <a:off x="2243915" y="1004765"/>
              <a:ext cx="547191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3EEC2C3B-6968-4597-A256-C98D28F36B28}"/>
                </a:ext>
              </a:extLst>
            </p:cNvPr>
            <p:cNvCxnSpPr/>
            <p:nvPr/>
          </p:nvCxnSpPr>
          <p:spPr>
            <a:xfrm>
              <a:off x="2243915" y="929748"/>
              <a:ext cx="784706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8FDD1BEF-A3E0-4FC0-9428-E720CA83FB8E}"/>
                </a:ext>
              </a:extLst>
            </p:cNvPr>
            <p:cNvSpPr txBox="1"/>
            <p:nvPr/>
          </p:nvSpPr>
          <p:spPr>
            <a:xfrm>
              <a:off x="2300854" y="1056886"/>
              <a:ext cx="1771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A5BBD597-A96F-49C7-8CC2-5774792E9910}"/>
                </a:ext>
              </a:extLst>
            </p:cNvPr>
            <p:cNvSpPr txBox="1"/>
            <p:nvPr/>
          </p:nvSpPr>
          <p:spPr>
            <a:xfrm>
              <a:off x="2518446" y="983447"/>
              <a:ext cx="27530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3605C958-2AB5-4C38-87CE-D41EB13B8DE5}"/>
                </a:ext>
              </a:extLst>
            </p:cNvPr>
            <p:cNvSpPr txBox="1"/>
            <p:nvPr/>
          </p:nvSpPr>
          <p:spPr>
            <a:xfrm>
              <a:off x="103999" y="919785"/>
              <a:ext cx="307777" cy="110122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ja-JP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%) in </a:t>
              </a:r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DCs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D6ED371A-1144-4296-9B40-9A5C96AF9059}"/>
                </a:ext>
              </a:extLst>
            </p:cNvPr>
            <p:cNvSpPr txBox="1"/>
            <p:nvPr/>
          </p:nvSpPr>
          <p:spPr>
            <a:xfrm>
              <a:off x="1624097" y="918184"/>
              <a:ext cx="307777" cy="110122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ja-JP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%) in </a:t>
              </a:r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DCs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E13F8DAA-542B-4A33-8F2E-FD0E74302C56}"/>
                </a:ext>
              </a:extLst>
            </p:cNvPr>
            <p:cNvSpPr txBox="1"/>
            <p:nvPr/>
          </p:nvSpPr>
          <p:spPr>
            <a:xfrm>
              <a:off x="1032938" y="2180103"/>
              <a:ext cx="419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other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(12)</a:t>
              </a:r>
            </a:p>
          </p:txBody>
        </p: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F0C1683C-1470-481A-9649-FE142A3F1874}"/>
                </a:ext>
              </a:extLst>
            </p:cNvPr>
            <p:cNvCxnSpPr/>
            <p:nvPr/>
          </p:nvCxnSpPr>
          <p:spPr>
            <a:xfrm>
              <a:off x="1144151" y="2461462"/>
              <a:ext cx="4297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03AA07FC-3C8B-4306-8CF5-71E3397188A6}"/>
                </a:ext>
              </a:extLst>
            </p:cNvPr>
            <p:cNvSpPr txBox="1"/>
            <p:nvPr/>
          </p:nvSpPr>
          <p:spPr>
            <a:xfrm>
              <a:off x="2679479" y="2440252"/>
              <a:ext cx="3751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aSLE</a:t>
              </a:r>
              <a:endParaRPr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2F202889-6F07-480C-9F08-91A74B84D645}"/>
                </a:ext>
              </a:extLst>
            </p:cNvPr>
            <p:cNvSpPr txBox="1"/>
            <p:nvPr/>
          </p:nvSpPr>
          <p:spPr>
            <a:xfrm>
              <a:off x="2838642" y="2186141"/>
              <a:ext cx="3227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LN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(30)</a:t>
              </a: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33DEF739-6490-4FDC-BB99-F91B147AD0EC}"/>
                </a:ext>
              </a:extLst>
            </p:cNvPr>
            <p:cNvSpPr txBox="1"/>
            <p:nvPr/>
          </p:nvSpPr>
          <p:spPr>
            <a:xfrm>
              <a:off x="2546896" y="2181781"/>
              <a:ext cx="419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other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(12)</a:t>
              </a:r>
            </a:p>
          </p:txBody>
        </p:sp>
        <p:cxnSp>
          <p:nvCxnSpPr>
            <p:cNvPr id="81" name="直線コネクタ 80">
              <a:extLst>
                <a:ext uri="{FF2B5EF4-FFF2-40B4-BE49-F238E27FC236}">
                  <a16:creationId xmlns:a16="http://schemas.microsoft.com/office/drawing/2014/main" id="{35885EBA-2C30-4A17-8911-2C341BE1A137}"/>
                </a:ext>
              </a:extLst>
            </p:cNvPr>
            <p:cNvCxnSpPr/>
            <p:nvPr/>
          </p:nvCxnSpPr>
          <p:spPr>
            <a:xfrm>
              <a:off x="2658109" y="2463140"/>
              <a:ext cx="4297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E27168F2-DD8F-4561-9EBF-BE9BE231EFC6}"/>
                </a:ext>
              </a:extLst>
            </p:cNvPr>
            <p:cNvSpPr txBox="1"/>
            <p:nvPr/>
          </p:nvSpPr>
          <p:spPr>
            <a:xfrm>
              <a:off x="1189377" y="789769"/>
              <a:ext cx="3819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r>
                <a:rPr lang="ja-JP" alt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altLang="ja-JP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880E0C93-FB82-4931-ADA0-EC5AF9C89F45}"/>
                </a:ext>
              </a:extLst>
            </p:cNvPr>
            <p:cNvSpPr txBox="1"/>
            <p:nvPr/>
          </p:nvSpPr>
          <p:spPr>
            <a:xfrm>
              <a:off x="2718599" y="924833"/>
              <a:ext cx="37655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pic>
          <p:nvPicPr>
            <p:cNvPr id="84" name="図 83">
              <a:extLst>
                <a:ext uri="{FF2B5EF4-FFF2-40B4-BE49-F238E27FC236}">
                  <a16:creationId xmlns:a16="http://schemas.microsoft.com/office/drawing/2014/main" id="{F82AAB58-A0C1-4374-8BA0-CF3B5F6B56B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697609" y="581358"/>
              <a:ext cx="1586012" cy="1981676"/>
            </a:xfrm>
            <a:prstGeom prst="rect">
              <a:avLst/>
            </a:prstGeom>
          </p:spPr>
        </p:pic>
        <p:pic>
          <p:nvPicPr>
            <p:cNvPr id="85" name="図 84">
              <a:extLst>
                <a:ext uri="{FF2B5EF4-FFF2-40B4-BE49-F238E27FC236}">
                  <a16:creationId xmlns:a16="http://schemas.microsoft.com/office/drawing/2014/main" id="{26E34FD7-A9AB-4459-BD8B-6DF7395C82C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227096" y="579681"/>
              <a:ext cx="1589365" cy="1985030"/>
            </a:xfrm>
            <a:prstGeom prst="rect">
              <a:avLst/>
            </a:prstGeom>
          </p:spPr>
        </p:pic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4490C7B7-AC48-41CD-874D-D9361DF17B22}"/>
                </a:ext>
              </a:extLst>
            </p:cNvPr>
            <p:cNvSpPr txBox="1"/>
            <p:nvPr/>
          </p:nvSpPr>
          <p:spPr>
            <a:xfrm>
              <a:off x="5839958" y="433115"/>
              <a:ext cx="6270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CpG2216</a:t>
              </a: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TLR9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0E2CBFC6-22E5-4C17-97E6-68E72F7203F2}"/>
                </a:ext>
              </a:extLst>
            </p:cNvPr>
            <p:cNvSpPr txBox="1"/>
            <p:nvPr/>
          </p:nvSpPr>
          <p:spPr>
            <a:xfrm>
              <a:off x="4325852" y="433115"/>
              <a:ext cx="6607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Loxoribine</a:t>
              </a:r>
              <a:endParaRPr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TLR7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1285FC9C-943C-4594-9D55-2BD83B437C4C}"/>
                </a:ext>
              </a:extLst>
            </p:cNvPr>
            <p:cNvSpPr txBox="1"/>
            <p:nvPr/>
          </p:nvSpPr>
          <p:spPr>
            <a:xfrm>
              <a:off x="3626640" y="927931"/>
              <a:ext cx="307777" cy="110122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ja-JP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%) in </a:t>
              </a:r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DCs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0D7F8313-0888-4C7B-B153-EAC77E1FA9B6}"/>
                </a:ext>
              </a:extLst>
            </p:cNvPr>
            <p:cNvSpPr txBox="1"/>
            <p:nvPr/>
          </p:nvSpPr>
          <p:spPr>
            <a:xfrm>
              <a:off x="5145599" y="926330"/>
              <a:ext cx="307777" cy="110122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ja-JP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%) in </a:t>
              </a:r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DCs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A6A9738C-DD68-4DF1-9015-393A7212572B}"/>
                </a:ext>
              </a:extLst>
            </p:cNvPr>
            <p:cNvSpPr txBox="1"/>
            <p:nvPr/>
          </p:nvSpPr>
          <p:spPr>
            <a:xfrm>
              <a:off x="3479776" y="373350"/>
              <a:ext cx="3311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ja-JP" altLang="en-US" sz="800" b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0A11F3FB-F549-4092-8682-6A6CFA514006}"/>
                </a:ext>
              </a:extLst>
            </p:cNvPr>
            <p:cNvSpPr txBox="1"/>
            <p:nvPr/>
          </p:nvSpPr>
          <p:spPr>
            <a:xfrm>
              <a:off x="9139" y="373350"/>
              <a:ext cx="3311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ja-JP" altLang="en-US" sz="800" b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228FDF91-271C-410E-90F0-93ABD6F1064A}"/>
                </a:ext>
              </a:extLst>
            </p:cNvPr>
            <p:cNvSpPr txBox="1"/>
            <p:nvPr/>
          </p:nvSpPr>
          <p:spPr>
            <a:xfrm>
              <a:off x="4045172" y="4530171"/>
              <a:ext cx="42200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naive</a:t>
              </a: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14308142-29C9-4A1B-93C4-51F504DB5E36}"/>
                </a:ext>
              </a:extLst>
            </p:cNvPr>
            <p:cNvSpPr txBox="1"/>
            <p:nvPr/>
          </p:nvSpPr>
          <p:spPr>
            <a:xfrm>
              <a:off x="4309638" y="4530171"/>
              <a:ext cx="35958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E13BA553-EB2D-4489-BB15-434FCDE3667E}"/>
                </a:ext>
              </a:extLst>
            </p:cNvPr>
            <p:cNvSpPr txBox="1"/>
            <p:nvPr/>
          </p:nvSpPr>
          <p:spPr>
            <a:xfrm>
              <a:off x="4765081" y="4530171"/>
              <a:ext cx="4374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TAC</a:t>
              </a: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C15CCA28-133A-4B58-8716-533D9CE7CD54}"/>
                </a:ext>
              </a:extLst>
            </p:cNvPr>
            <p:cNvSpPr txBox="1"/>
            <p:nvPr/>
          </p:nvSpPr>
          <p:spPr>
            <a:xfrm>
              <a:off x="3625916" y="3257153"/>
              <a:ext cx="307777" cy="110122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ja-JP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%) in </a:t>
              </a:r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DCs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BF643DCF-5BA4-4193-93F6-3425F90DDC7D}"/>
                </a:ext>
              </a:extLst>
            </p:cNvPr>
            <p:cNvSpPr txBox="1"/>
            <p:nvPr/>
          </p:nvSpPr>
          <p:spPr>
            <a:xfrm>
              <a:off x="5147153" y="3255552"/>
              <a:ext cx="307777" cy="110122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ja-JP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%) in </a:t>
              </a:r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DCs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6693BF07-9C30-4314-9A2C-0F0D2D50C641}"/>
                </a:ext>
              </a:extLst>
            </p:cNvPr>
            <p:cNvSpPr txBox="1"/>
            <p:nvPr/>
          </p:nvSpPr>
          <p:spPr>
            <a:xfrm>
              <a:off x="4528993" y="4530171"/>
              <a:ext cx="41998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AZA</a:t>
              </a: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F4C742A7-53D3-40D7-91B5-80B2778B6D26}"/>
                </a:ext>
              </a:extLst>
            </p:cNvPr>
            <p:cNvSpPr txBox="1"/>
            <p:nvPr/>
          </p:nvSpPr>
          <p:spPr>
            <a:xfrm>
              <a:off x="5611251" y="4530171"/>
              <a:ext cx="42200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naive</a:t>
              </a: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475F8C2E-2509-4B5A-9A07-F1474BDCBAE0}"/>
                </a:ext>
              </a:extLst>
            </p:cNvPr>
            <p:cNvSpPr txBox="1"/>
            <p:nvPr/>
          </p:nvSpPr>
          <p:spPr>
            <a:xfrm>
              <a:off x="5882067" y="4530171"/>
              <a:ext cx="35958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605DACEF-C5D3-495F-9B52-48673FDC5383}"/>
                </a:ext>
              </a:extLst>
            </p:cNvPr>
            <p:cNvSpPr txBox="1"/>
            <p:nvPr/>
          </p:nvSpPr>
          <p:spPr>
            <a:xfrm>
              <a:off x="6318460" y="4530171"/>
              <a:ext cx="4374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TAC</a:t>
              </a: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57A15F75-E2E5-4377-BF7E-865D4BF00E76}"/>
                </a:ext>
              </a:extLst>
            </p:cNvPr>
            <p:cNvSpPr txBox="1"/>
            <p:nvPr/>
          </p:nvSpPr>
          <p:spPr>
            <a:xfrm>
              <a:off x="6095072" y="4530171"/>
              <a:ext cx="41998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AZA</a:t>
              </a: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CA7A204B-2FE7-429F-8F0C-1B9EF75F3C16}"/>
                </a:ext>
              </a:extLst>
            </p:cNvPr>
            <p:cNvSpPr txBox="1"/>
            <p:nvPr/>
          </p:nvSpPr>
          <p:spPr>
            <a:xfrm>
              <a:off x="4064946" y="2190814"/>
              <a:ext cx="42200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naive</a:t>
              </a: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F8ED7012-0DBE-4F26-9ECB-C4A7794B7649}"/>
                </a:ext>
              </a:extLst>
            </p:cNvPr>
            <p:cNvSpPr txBox="1"/>
            <p:nvPr/>
          </p:nvSpPr>
          <p:spPr>
            <a:xfrm>
              <a:off x="4329412" y="2190814"/>
              <a:ext cx="35958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4666CB39-C36B-4A7D-B269-1A8731D55C35}"/>
                </a:ext>
              </a:extLst>
            </p:cNvPr>
            <p:cNvSpPr txBox="1"/>
            <p:nvPr/>
          </p:nvSpPr>
          <p:spPr>
            <a:xfrm>
              <a:off x="4784855" y="2190814"/>
              <a:ext cx="4374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TAC</a:t>
              </a: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2B45063B-5B82-46A4-998E-739847C2C303}"/>
                </a:ext>
              </a:extLst>
            </p:cNvPr>
            <p:cNvSpPr txBox="1"/>
            <p:nvPr/>
          </p:nvSpPr>
          <p:spPr>
            <a:xfrm>
              <a:off x="4548767" y="2190814"/>
              <a:ext cx="41998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AZA</a:t>
              </a: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B984FCC7-F1FE-4165-9A5E-0EB23242F4DA}"/>
                </a:ext>
              </a:extLst>
            </p:cNvPr>
            <p:cNvSpPr txBox="1"/>
            <p:nvPr/>
          </p:nvSpPr>
          <p:spPr>
            <a:xfrm>
              <a:off x="5592925" y="2192145"/>
              <a:ext cx="42200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naive</a:t>
              </a: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814EAA57-E95A-449A-B2B9-0B56109B40AB}"/>
                </a:ext>
              </a:extLst>
            </p:cNvPr>
            <p:cNvSpPr txBox="1"/>
            <p:nvPr/>
          </p:nvSpPr>
          <p:spPr>
            <a:xfrm>
              <a:off x="5857391" y="2192145"/>
              <a:ext cx="35958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583617CB-A804-4A11-9589-2F287C768BC8}"/>
                </a:ext>
              </a:extLst>
            </p:cNvPr>
            <p:cNvSpPr txBox="1"/>
            <p:nvPr/>
          </p:nvSpPr>
          <p:spPr>
            <a:xfrm>
              <a:off x="6312834" y="2192145"/>
              <a:ext cx="4374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TAC</a:t>
              </a: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A0067333-6D85-4FD4-8761-813C66F3A7A4}"/>
                </a:ext>
              </a:extLst>
            </p:cNvPr>
            <p:cNvSpPr txBox="1"/>
            <p:nvPr/>
          </p:nvSpPr>
          <p:spPr>
            <a:xfrm>
              <a:off x="6076746" y="2192145"/>
              <a:ext cx="41998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AZA</a:t>
              </a: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C65977E1-F0CF-443F-BAB5-7C559626D21B}"/>
                </a:ext>
              </a:extLst>
            </p:cNvPr>
            <p:cNvSpPr txBox="1"/>
            <p:nvPr/>
          </p:nvSpPr>
          <p:spPr>
            <a:xfrm>
              <a:off x="5836737" y="2827397"/>
              <a:ext cx="6270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CpG2216</a:t>
              </a: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TLR9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5E9C336E-B94B-4126-AEF3-E93405C7D908}"/>
                </a:ext>
              </a:extLst>
            </p:cNvPr>
            <p:cNvSpPr txBox="1"/>
            <p:nvPr/>
          </p:nvSpPr>
          <p:spPr>
            <a:xfrm>
              <a:off x="4322631" y="2827397"/>
              <a:ext cx="6607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Loxoribine</a:t>
              </a:r>
              <a:endParaRPr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TLR7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D8BFFC45-1E2D-4BB4-931A-89CAE6658FEC}"/>
                </a:ext>
              </a:extLst>
            </p:cNvPr>
            <p:cNvSpPr txBox="1"/>
            <p:nvPr/>
          </p:nvSpPr>
          <p:spPr>
            <a:xfrm>
              <a:off x="3479776" y="2747645"/>
              <a:ext cx="3311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ja-JP" altLang="en-US" sz="800" b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6FE88178-401C-448B-884E-F5D28E1CC78C}"/>
                </a:ext>
              </a:extLst>
            </p:cNvPr>
            <p:cNvSpPr txBox="1"/>
            <p:nvPr/>
          </p:nvSpPr>
          <p:spPr>
            <a:xfrm>
              <a:off x="539972" y="4530171"/>
              <a:ext cx="42200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naive</a:t>
              </a: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1F67ABD6-ACED-4313-BF5A-5673BF28310E}"/>
                </a:ext>
              </a:extLst>
            </p:cNvPr>
            <p:cNvSpPr txBox="1"/>
            <p:nvPr/>
          </p:nvSpPr>
          <p:spPr>
            <a:xfrm>
              <a:off x="823488" y="4530171"/>
              <a:ext cx="35958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3823E836-E7D3-4C97-B5AC-9833E9896564}"/>
                </a:ext>
              </a:extLst>
            </p:cNvPr>
            <p:cNvSpPr txBox="1"/>
            <p:nvPr/>
          </p:nvSpPr>
          <p:spPr>
            <a:xfrm>
              <a:off x="1285281" y="4530171"/>
              <a:ext cx="4374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TAC</a:t>
              </a: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F47C935A-5536-4FB9-B13A-1548D2FA5C9C}"/>
                </a:ext>
              </a:extLst>
            </p:cNvPr>
            <p:cNvSpPr txBox="1"/>
            <p:nvPr/>
          </p:nvSpPr>
          <p:spPr>
            <a:xfrm>
              <a:off x="101666" y="3225403"/>
              <a:ext cx="307777" cy="110122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ja-JP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%) in </a:t>
              </a:r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DCs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F9859E6A-56A0-4B30-A5E9-78B1F22E5B54}"/>
                </a:ext>
              </a:extLst>
            </p:cNvPr>
            <p:cNvSpPr txBox="1"/>
            <p:nvPr/>
          </p:nvSpPr>
          <p:spPr>
            <a:xfrm>
              <a:off x="1635603" y="3223802"/>
              <a:ext cx="307777" cy="110122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l-GR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ja-JP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%) in </a:t>
              </a:r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DCs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726C28F7-808A-45CF-9431-5DF27B3C4A84}"/>
                </a:ext>
              </a:extLst>
            </p:cNvPr>
            <p:cNvSpPr txBox="1"/>
            <p:nvPr/>
          </p:nvSpPr>
          <p:spPr>
            <a:xfrm>
              <a:off x="1036493" y="4530171"/>
              <a:ext cx="41998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AZA</a:t>
              </a:r>
            </a:p>
          </p:txBody>
        </p: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6190ECB0-7FAD-4155-9EC3-167692B89AFB}"/>
                </a:ext>
              </a:extLst>
            </p:cNvPr>
            <p:cNvSpPr txBox="1"/>
            <p:nvPr/>
          </p:nvSpPr>
          <p:spPr>
            <a:xfrm>
              <a:off x="2112401" y="4530171"/>
              <a:ext cx="42200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naive</a:t>
              </a:r>
            </a:p>
          </p:txBody>
        </p: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4D768669-6D5E-4A05-ADCC-0523B941E58A}"/>
                </a:ext>
              </a:extLst>
            </p:cNvPr>
            <p:cNvSpPr txBox="1"/>
            <p:nvPr/>
          </p:nvSpPr>
          <p:spPr>
            <a:xfrm>
              <a:off x="2395917" y="4530171"/>
              <a:ext cx="35958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</p:txBody>
        </p: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0B8D159C-36CA-42AD-842F-C374A13BEE6A}"/>
                </a:ext>
              </a:extLst>
            </p:cNvPr>
            <p:cNvSpPr txBox="1"/>
            <p:nvPr/>
          </p:nvSpPr>
          <p:spPr>
            <a:xfrm>
              <a:off x="2857710" y="4530171"/>
              <a:ext cx="4374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TAC</a:t>
              </a: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08AF5581-B67E-4176-A6A5-17FAA982BB59}"/>
                </a:ext>
              </a:extLst>
            </p:cNvPr>
            <p:cNvSpPr txBox="1"/>
            <p:nvPr/>
          </p:nvSpPr>
          <p:spPr>
            <a:xfrm>
              <a:off x="2608922" y="4530171"/>
              <a:ext cx="41998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SL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AZA</a:t>
              </a:r>
            </a:p>
          </p:txBody>
        </p: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6C9A497C-9E4B-4917-8674-5862ED4CC43C}"/>
                </a:ext>
              </a:extLst>
            </p:cNvPr>
            <p:cNvSpPr txBox="1"/>
            <p:nvPr/>
          </p:nvSpPr>
          <p:spPr>
            <a:xfrm>
              <a:off x="2299787" y="2827397"/>
              <a:ext cx="6270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CpG2216</a:t>
              </a: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TLR9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B0EA4DEF-6006-4758-967D-B35390554EF7}"/>
                </a:ext>
              </a:extLst>
            </p:cNvPr>
            <p:cNvSpPr txBox="1"/>
            <p:nvPr/>
          </p:nvSpPr>
          <p:spPr>
            <a:xfrm>
              <a:off x="785681" y="2827397"/>
              <a:ext cx="6607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Loxoribine</a:t>
              </a:r>
              <a:endParaRPr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TLR7)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8A65B58A-DC14-44DB-8C63-566EADB241F7}"/>
                </a:ext>
              </a:extLst>
            </p:cNvPr>
            <p:cNvSpPr txBox="1"/>
            <p:nvPr/>
          </p:nvSpPr>
          <p:spPr>
            <a:xfrm>
              <a:off x="9139" y="2747645"/>
              <a:ext cx="3311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ja-JP" altLang="en-US" sz="800" b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6702364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31</TotalTime>
  <Words>173</Words>
  <Application>Microsoft Office PowerPoint</Application>
  <PresentationFormat>画面に合わせる (4:3)</PresentationFormat>
  <Paragraphs>10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Symbol</vt:lpstr>
      <vt:lpstr>ホワイト</vt:lpstr>
      <vt:lpstr>PowerPoint プレゼンテーション</vt:lpstr>
    </vt:vector>
  </TitlesOfParts>
  <Company>UOE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WATA SHIGERU</dc:creator>
  <cp:lastModifiedBy>圭 阪田</cp:lastModifiedBy>
  <cp:revision>302</cp:revision>
  <cp:lastPrinted>2017-04-10T01:20:45Z</cp:lastPrinted>
  <dcterms:created xsi:type="dcterms:W3CDTF">2016-08-30T03:40:23Z</dcterms:created>
  <dcterms:modified xsi:type="dcterms:W3CDTF">2018-07-25T02:21:37Z</dcterms:modified>
</cp:coreProperties>
</file>